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86" d="100"/>
          <a:sy n="86" d="100"/>
        </p:scale>
        <p:origin x="6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y%20Drive\qtls3\eqtlgen_ukbb\with_hla\stats\node_distribution_v3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power_law!$D$1</c:f>
              <c:strCache>
                <c:ptCount val="1"/>
              </c:strCache>
            </c:strRef>
          </c:tx>
          <c:spPr>
            <a:ln w="38100">
              <a:solidFill>
                <a:srgbClr val="00B050"/>
              </a:solidFill>
            </a:ln>
          </c:spPr>
          <c:marker>
            <c:symbol val="circle"/>
            <c:size val="7"/>
            <c:spPr>
              <a:solidFill>
                <a:srgbClr val="00B050">
                  <a:alpha val="98000"/>
                </a:srgbClr>
              </a:solidFill>
              <a:ln w="38100" cmpd="sng">
                <a:solidFill>
                  <a:srgbClr val="00B050"/>
                </a:solidFill>
              </a:ln>
            </c:spPr>
          </c:marker>
          <c:xVal>
            <c:numRef>
              <c:f>power_law!$B$2:$B$20</c:f>
              <c:numCache>
                <c:formatCode>General</c:formatCode>
                <c:ptCount val="19"/>
                <c:pt idx="0">
                  <c:v>85</c:v>
                </c:pt>
                <c:pt idx="1">
                  <c:v>35</c:v>
                </c:pt>
                <c:pt idx="2">
                  <c:v>19</c:v>
                </c:pt>
                <c:pt idx="3">
                  <c:v>16</c:v>
                </c:pt>
                <c:pt idx="4">
                  <c:v>15</c:v>
                </c:pt>
                <c:pt idx="5">
                  <c:v>14</c:v>
                </c:pt>
                <c:pt idx="6">
                  <c:v>13</c:v>
                </c:pt>
                <c:pt idx="7">
                  <c:v>12</c:v>
                </c:pt>
                <c:pt idx="8">
                  <c:v>11</c:v>
                </c:pt>
                <c:pt idx="9">
                  <c:v>10</c:v>
                </c:pt>
                <c:pt idx="10">
                  <c:v>9</c:v>
                </c:pt>
                <c:pt idx="11">
                  <c:v>8</c:v>
                </c:pt>
                <c:pt idx="12">
                  <c:v>7</c:v>
                </c:pt>
                <c:pt idx="13">
                  <c:v>6</c:v>
                </c:pt>
                <c:pt idx="14">
                  <c:v>5</c:v>
                </c:pt>
                <c:pt idx="15">
                  <c:v>4</c:v>
                </c:pt>
                <c:pt idx="16">
                  <c:v>3</c:v>
                </c:pt>
                <c:pt idx="17">
                  <c:v>2</c:v>
                </c:pt>
                <c:pt idx="18">
                  <c:v>1</c:v>
                </c:pt>
              </c:numCache>
            </c:numRef>
          </c:xVal>
          <c:yVal>
            <c:numRef>
              <c:f>power_law!$C$2:$C$20</c:f>
              <c:numCache>
                <c:formatCode>General</c:formatCode>
                <c:ptCount val="1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1</c:v>
                </c:pt>
                <c:pt idx="5">
                  <c:v>1</c:v>
                </c:pt>
                <c:pt idx="6">
                  <c:v>2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5</c:v>
                </c:pt>
                <c:pt idx="11">
                  <c:v>4</c:v>
                </c:pt>
                <c:pt idx="12">
                  <c:v>4</c:v>
                </c:pt>
                <c:pt idx="13">
                  <c:v>11</c:v>
                </c:pt>
                <c:pt idx="14">
                  <c:v>8</c:v>
                </c:pt>
                <c:pt idx="15">
                  <c:v>27</c:v>
                </c:pt>
                <c:pt idx="16">
                  <c:v>39</c:v>
                </c:pt>
                <c:pt idx="17">
                  <c:v>107</c:v>
                </c:pt>
                <c:pt idx="18">
                  <c:v>25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8F0-45B5-9F35-234261F53E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8830495"/>
        <c:axId val="119806239"/>
      </c:scatterChart>
      <c:valAx>
        <c:axId val="988830495"/>
        <c:scaling>
          <c:orientation val="minMax"/>
          <c:max val="90"/>
          <c:min val="0"/>
        </c:scaling>
        <c:delete val="0"/>
        <c:axPos val="b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en-CA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38100">
            <a:solidFill>
              <a:schemeClr val="bg1">
                <a:lumMod val="50000"/>
              </a:schemeClr>
            </a:solidFill>
          </a:ln>
        </c:spPr>
        <c:txPr>
          <a:bodyPr/>
          <a:lstStyle/>
          <a:p>
            <a:pPr lvl="0">
              <a:defRPr sz="1600" b="1" i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</a:defRPr>
            </a:pPr>
            <a:endParaRPr lang="en-US"/>
          </a:p>
        </c:txPr>
        <c:crossAx val="119806239"/>
        <c:crosses val="autoZero"/>
        <c:crossBetween val="midCat"/>
      </c:valAx>
      <c:valAx>
        <c:axId val="119806239"/>
        <c:scaling>
          <c:orientation val="minMax"/>
          <c:max val="280"/>
          <c:min val="0"/>
        </c:scaling>
        <c:delete val="0"/>
        <c:axPos val="l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en-CA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38100">
            <a:solidFill>
              <a:schemeClr val="bg1">
                <a:lumMod val="50000"/>
              </a:schemeClr>
            </a:solidFill>
          </a:ln>
        </c:spPr>
        <c:txPr>
          <a:bodyPr/>
          <a:lstStyle/>
          <a:p>
            <a:pPr lvl="0">
              <a:defRPr sz="1600" b="1" i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</a:defRPr>
            </a:pPr>
            <a:endParaRPr lang="en-US"/>
          </a:p>
        </c:txPr>
        <c:crossAx val="988830495"/>
        <c:crosses val="autoZero"/>
        <c:crossBetween val="midCat"/>
        <c:majorUnit val="100"/>
      </c:valAx>
    </c:plotArea>
    <c:plotVisOnly val="1"/>
    <c:dispBlanksAs val="zero"/>
    <c:showDLblsOverMax val="1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3C50E2-EF6C-CD76-ACE0-4CA65A6E7A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A96CDC-CDC0-EF44-FDA7-E20E1DF23A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B5555-3890-C04F-BB8D-15D8A61AA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229D50-A2B6-C50C-FAF5-6E904A84F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4BBA27-2CA8-0E91-2898-9726F1E8D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6545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7F909B-E93A-AEF6-3DFB-9DE6BC83BD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3C45CE-6EE2-B6DF-8447-CC6A89DD32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C23FB-5149-BCFF-D62D-65025EBE1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B3FAC9-FFAD-77E5-59BB-31BF7AAB2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008A1D-2F8A-1C6D-0676-3ABF4A0CC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92137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A514F5-50BB-E7A4-C88E-2E45573107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326A9A-32ED-5F05-3EFB-E133B4EB31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68823-ECF7-5221-7A29-BD09BE1CE0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9DD640-EB42-28E6-824B-19D9062BD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59522A-168A-9A20-2180-78867B369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1979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D45272-69A0-674C-09F7-06ED448919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0FE2A3-77A4-28FD-124B-FCAB984C15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4E8C33-45EE-0DE6-5026-7D29AD32A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8AF381-E201-26C9-7199-313358C6E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BE7C73-7AA4-1260-C482-33831905C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9518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BE0853-2162-A572-7835-28A792016B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916772-9BCA-2FB0-74E6-70F5D26533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02950F-C4D1-1BB7-38CF-E98BD48EF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514A4A-5B77-59A8-A4E2-B2802D395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8F0703-9729-0AF5-454F-E8EAA6552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50706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B76A7-38C1-0C07-9CD3-1616FBBB85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9A9359-8FBA-5DAC-1F42-6D282050AF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73CFA6-8987-ACCD-BE7B-05EA546BC8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75C96B-9CE5-3910-BBBF-8D6FE4C59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B51C50-8A63-9FC3-F5ED-AEFBA9049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306975-387D-C3C8-BD46-DF2880615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45008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69CBE-A101-57BA-5A75-CDCA0724D6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E63E80-850E-FD7B-9BE3-CD152F25B5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4899A9-0B0C-3756-DF70-D075B59349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41B403-FF00-DEDC-DBE2-81D385D9E8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29BCA1-D1AC-517B-D4C0-42E62AF832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0AF9E0-B7BB-FD45-06C3-648E9CF1F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F303E9-52E1-D8CA-47AB-4D09886F1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9CF4A81-A563-BE88-8F58-7ACCED27B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89345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EDE36-594F-038B-3FDA-726687A09E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AC14812-3523-7759-3984-224D0A2F6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EE9C42-4270-57DD-906D-4FDCCA025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C4C10E7-E3A0-3CFA-B60B-364E3F96D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23940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516F61-6263-B68B-B037-0C9DF21ED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6BE5ECA-90DE-3E04-2714-51ED38745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24BA83-4D31-8198-AEAB-EB9702BB3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7670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B8418-99E5-830C-23E0-685B165EF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06C31B-47AE-47F9-F8B7-5DFDBB6D9D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99DBFF-065E-B09F-98BC-0F8F332CF0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2675BC-D483-3D77-C96F-DBCF38A55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5FE99D-9731-3BF4-1ABF-D1412B62A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BDB1B4-4D52-90C8-EE0F-20A366FF4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7747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DA38B9-7455-56C9-26A1-E328B39316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E8A4F6-A9CC-F5B0-FA95-2B0C743C35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9B05D3-28CD-017D-A0C1-2715E7374A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925EA-80D0-0DE3-DF07-2D52DCA2B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B5C048-223E-012B-AFA4-F82D31B3B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0ED3AD-5A78-05AA-6AE4-D9A9F0056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17629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C0C5C1-CD2D-9740-0AEB-F2235BE3AF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A81E0B-2F9A-DF78-3EC3-E67257139F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5D58C2-626E-E65F-0969-1A6C515B5A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4124FB-5C47-41D1-A61E-E89CF435A4EA}" type="datetimeFigureOut">
              <a:rPr lang="en-CA" smtClean="0"/>
              <a:t>2025-07-2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B6453B-2205-BC2F-A734-D37AEEFAB6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4082A5-062E-DDCB-2836-993A672CBF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11C61-1561-4A0C-BE7E-F6D8BC9F2F3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11619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FF1B9937-8081-48B0-B32F-F1B6B31F7F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0269488"/>
              </p:ext>
            </p:extLst>
          </p:nvPr>
        </p:nvGraphicFramePr>
        <p:xfrm>
          <a:off x="2078421" y="544837"/>
          <a:ext cx="6248882" cy="47287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4157A78-7B0B-A0BD-FF19-82519239F624}"/>
              </a:ext>
            </a:extLst>
          </p:cNvPr>
          <p:cNvSpPr txBox="1"/>
          <p:nvPr/>
        </p:nvSpPr>
        <p:spPr>
          <a:xfrm>
            <a:off x="2901620" y="5072845"/>
            <a:ext cx="511843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00" b="1" dirty="0"/>
              <a:t>Number of edg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012C15-1F4D-32B0-700C-3C8DA7067CA1}"/>
              </a:ext>
            </a:extLst>
          </p:cNvPr>
          <p:cNvSpPr txBox="1"/>
          <p:nvPr/>
        </p:nvSpPr>
        <p:spPr>
          <a:xfrm rot="16200000">
            <a:off x="254307" y="2458856"/>
            <a:ext cx="3861955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00" b="1" dirty="0"/>
              <a:t>Frequency of nod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D03782-7BB4-8DD5-9A35-B726BB75FCF6}"/>
              </a:ext>
            </a:extLst>
          </p:cNvPr>
          <p:cNvSpPr txBox="1"/>
          <p:nvPr/>
        </p:nvSpPr>
        <p:spPr>
          <a:xfrm>
            <a:off x="8636875" y="852582"/>
            <a:ext cx="2459421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1 Figure. The distribution of the number of edges by the frequency of nodes. </a:t>
            </a:r>
            <a:r>
              <a:rPr lang="en-US" sz="1400" b="0" i="0" dirty="0">
                <a:effectLst/>
                <a:latin typeface="Europa"/>
              </a:rPr>
              <a:t>Majority of nodes have few edges, while a few nodes (i.e. hub genes) account for a large number of edges.</a:t>
            </a:r>
            <a:r>
              <a:rPr lang="en-US" sz="1400" dirty="0"/>
              <a:t> To generate the graph, number of edges per node was calculated, then nodes (N=474) where grouped according to their number of edges and the plot was generated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79B70FE-DADB-7032-63B8-2D7FCDA74C25}"/>
              </a:ext>
            </a:extLst>
          </p:cNvPr>
          <p:cNvSpPr txBox="1"/>
          <p:nvPr/>
        </p:nvSpPr>
        <p:spPr>
          <a:xfrm>
            <a:off x="4238625" y="331470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y=131x</a:t>
            </a:r>
            <a:r>
              <a:rPr lang="en-CA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.5</a:t>
            </a:r>
          </a:p>
        </p:txBody>
      </p:sp>
    </p:spTree>
    <p:extLst>
      <p:ext uri="{BB962C8B-B14F-4D97-AF65-F5344CB8AC3E}">
        <p14:creationId xmlns:p14="http://schemas.microsoft.com/office/powerpoint/2010/main" val="2936455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</TotalTime>
  <Words>86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Europ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id Nikpay</dc:creator>
  <cp:lastModifiedBy>Majid Nikpay</cp:lastModifiedBy>
  <cp:revision>11</cp:revision>
  <dcterms:created xsi:type="dcterms:W3CDTF">2023-12-05T16:25:18Z</dcterms:created>
  <dcterms:modified xsi:type="dcterms:W3CDTF">2025-07-22T22:17:52Z</dcterms:modified>
</cp:coreProperties>
</file>